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630" y="10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oxanne Assies" userId="7664e6967585e71c" providerId="LiveId" clId="{FB38712C-A40B-45E8-8071-A7C1FE1360CD}"/>
    <pc:docChg chg="modSld">
      <pc:chgData name="Roxanne Assies" userId="7664e6967585e71c" providerId="LiveId" clId="{FB38712C-A40B-45E8-8071-A7C1FE1360CD}" dt="2022-05-05T12:38:28.401" v="17" actId="1076"/>
      <pc:docMkLst>
        <pc:docMk/>
      </pc:docMkLst>
      <pc:sldChg chg="modSp mod">
        <pc:chgData name="Roxanne Assies" userId="7664e6967585e71c" providerId="LiveId" clId="{FB38712C-A40B-45E8-8071-A7C1FE1360CD}" dt="2022-05-05T12:38:28.401" v="17" actId="1076"/>
        <pc:sldMkLst>
          <pc:docMk/>
          <pc:sldMk cId="3747067619" sldId="265"/>
        </pc:sldMkLst>
        <pc:spChg chg="mod">
          <ac:chgData name="Roxanne Assies" userId="7664e6967585e71c" providerId="LiveId" clId="{FB38712C-A40B-45E8-8071-A7C1FE1360CD}" dt="2022-05-05T12:38:28.401" v="17" actId="1076"/>
          <ac:spMkLst>
            <pc:docMk/>
            <pc:sldMk cId="3747067619" sldId="265"/>
            <ac:spMk id="11" creationId="{A6886AB1-66B7-4B3C-B2EE-4A80D5296D04}"/>
          </ac:spMkLst>
        </pc:spChg>
        <pc:picChg chg="mod modCrop">
          <ac:chgData name="Roxanne Assies" userId="7664e6967585e71c" providerId="LiveId" clId="{FB38712C-A40B-45E8-8071-A7C1FE1360CD}" dt="2022-05-05T12:37:38.914" v="9" actId="732"/>
          <ac:picMkLst>
            <pc:docMk/>
            <pc:sldMk cId="3747067619" sldId="265"/>
            <ac:picMk id="8" creationId="{9D9314D2-4224-4476-BC26-4991D98AED9E}"/>
          </ac:picMkLst>
        </pc:picChg>
        <pc:picChg chg="mod">
          <ac:chgData name="Roxanne Assies" userId="7664e6967585e71c" providerId="LiveId" clId="{FB38712C-A40B-45E8-8071-A7C1FE1360CD}" dt="2022-05-05T12:36:33.965" v="5" actId="1076"/>
          <ac:picMkLst>
            <pc:docMk/>
            <pc:sldMk cId="3747067619" sldId="265"/>
            <ac:picMk id="9" creationId="{D68C6964-8A8D-4ED5-B973-972D8E4B770D}"/>
          </ac:picMkLst>
        </pc:picChg>
        <pc:picChg chg="mod">
          <ac:chgData name="Roxanne Assies" userId="7664e6967585e71c" providerId="LiveId" clId="{FB38712C-A40B-45E8-8071-A7C1FE1360CD}" dt="2022-05-05T12:38:04.424" v="13" actId="1076"/>
          <ac:picMkLst>
            <pc:docMk/>
            <pc:sldMk cId="3747067619" sldId="265"/>
            <ac:picMk id="10" creationId="{C9B742C1-185B-4E0B-9850-EB27F88D3B2B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0DCFA5-6270-BE3E-B115-EC92EEA8C7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A7DF18F-0B04-82B6-E215-9E772E7E8D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AFAA15-4636-37D5-8573-2DABD7C1E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C51BC-2D46-4DE6-B12D-B418A9D8B84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615B7E-AC55-DCEE-7BF3-0F6F098C20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D3A5B5-F081-3256-8A32-D1E195A85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C7B18-4F52-44FF-8E20-8A6719BF9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05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424561-1662-F03B-89DF-13275B8294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822A23-FCD1-E356-7088-9196CBEDD1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842D87-CD94-1E0D-CD4D-F7F61918FA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C51BC-2D46-4DE6-B12D-B418A9D8B84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0A1562-0C1D-69E8-483A-2E2F1AA458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0EE938-AA5E-7872-0B7C-D04F29092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C7B18-4F52-44FF-8E20-8A6719BF9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447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B46EDFB-A8FC-D2E8-3DD4-D0965443F6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E624EE-3B1C-0C42-CF3E-271E966298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0CA617-B757-DF88-A56B-E8FF1696FE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C51BC-2D46-4DE6-B12D-B418A9D8B84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02332C-5F92-F199-4F4F-A3FFE47D18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B40CB8-2583-5508-B810-B4F44207D9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C7B18-4F52-44FF-8E20-8A6719BF9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756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CDBE87-A095-05B2-FD47-300AF895DD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99D4E7-F82D-2C14-A980-DE79187A0E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C1565E-0C40-F6A2-DA7F-A3B029490C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C51BC-2D46-4DE6-B12D-B418A9D8B84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3C9C7E-0D61-5B27-DFB5-4E8CCACC32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5553E0-41D2-F07D-2E58-04B5F706EF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C7B18-4F52-44FF-8E20-8A6719BF9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506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D48311-FD8C-57D9-5CB6-C6EE2659BF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0536FE-543E-A31A-F6C9-A75E78FFDF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57EAED-CFB5-FB79-CB0E-6A828EA69E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C51BC-2D46-4DE6-B12D-B418A9D8B84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9FCE16-1BEC-85DE-6F50-0B6B10AE2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332906-C2D2-9B01-D666-2D237D129E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C7B18-4F52-44FF-8E20-8A6719BF9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3176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CBB8B2-0B8A-CBCE-091A-A16C84987B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DF03AF-885C-8CE1-E2CC-2FE9C7422B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DD452C-9F14-0A1D-565D-B00C423D11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015B48-CEDA-F41F-CECB-E852415A0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C51BC-2D46-4DE6-B12D-B418A9D8B84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DBB3A4-8172-72AE-B494-22ED192E3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5D777B-D871-F295-1675-CE6F69BFA0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C7B18-4F52-44FF-8E20-8A6719BF9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0763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545F0B-8E41-F2AA-172B-FA13994F90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BE6E0F-EA48-4D9C-F46E-72A065C0E9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FD8EE5-389F-A72A-DBD7-90CA1897E8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740E81-AAB9-1BA4-6876-82C5D9DB88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487F8CA-81C5-7421-163A-AEF99724D02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DA0756-0C14-7CDA-1DFB-C776B74C8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C51BC-2D46-4DE6-B12D-B418A9D8B84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9A0479F-0928-4961-B6AC-606C63075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CACF4A-2067-816E-74F1-364338C0EB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C7B18-4F52-44FF-8E20-8A6719BF9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636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E27CC1-E4E7-5D06-6724-CE6959A097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322226E-0113-96CF-3B83-EF75A2273B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C51BC-2D46-4DE6-B12D-B418A9D8B84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6D8DF10-95BB-CF2E-699C-305477483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75E76EE-91FD-A5DB-8FE0-EA8B408D0B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C7B18-4F52-44FF-8E20-8A6719BF9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085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2797435-4D78-15D2-9F83-CFAD622AEA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C51BC-2D46-4DE6-B12D-B418A9D8B84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52F07C-76D9-1D4F-7159-C73C32E2AD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56FF2D6-4ACE-9248-66D1-3EAF4084F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C7B18-4F52-44FF-8E20-8A6719BF9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734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761A2-FF16-EDDB-7DFF-31F74C75B1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F3604B-2D8A-75D4-7E2D-A871E1ABBA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DE129E0-38E1-A220-D1AD-B7DD23BABE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7294C6-5C07-661F-7B7F-A7F46E639B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C51BC-2D46-4DE6-B12D-B418A9D8B84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E12406-EF5F-E36A-EDEC-860B07C8FF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B67C18-C18A-4CF1-8A31-5D391D931A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C7B18-4F52-44FF-8E20-8A6719BF9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049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5A174-C61B-16BB-D1FC-C2DF388D4C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9F819F1-9274-2894-5993-11BED2A266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CAAAE5-8688-BCFA-3D18-DFF5633335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DF8C5A-F1E6-2C81-4C1E-F692779EE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7C51BC-2D46-4DE6-B12D-B418A9D8B84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10792C-2D5E-6699-AE34-509D3A9AF4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5F8906-408B-084F-28C2-47D662206F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C7B18-4F52-44FF-8E20-8A6719BF9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949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96C097-A340-0694-1D30-650205AD1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519229-7241-E3FA-F6C8-5E42897F45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00F85D-FC68-3F74-966A-08584B4CA7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7C51BC-2D46-4DE6-B12D-B418A9D8B84D}" type="datetimeFigureOut">
              <a:rPr lang="en-US" smtClean="0"/>
              <a:t>5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B345F1-7B20-03AD-D2CC-5F3E3162D8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244F7D-5F99-5E02-4A84-FD8F31D2CB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FC7B18-4F52-44FF-8E20-8A6719BF9B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11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Diagram&#10;&#10;Description automatically generated">
            <a:extLst>
              <a:ext uri="{FF2B5EF4-FFF2-40B4-BE49-F238E27FC236}">
                <a16:creationId xmlns:a16="http://schemas.microsoft.com/office/drawing/2014/main" id="{9D9314D2-4224-4476-BC26-4991D98AED9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88" b="90741"/>
          <a:stretch/>
        </p:blipFill>
        <p:spPr>
          <a:xfrm>
            <a:off x="5727081" y="0"/>
            <a:ext cx="5682795" cy="646918"/>
          </a:xfrm>
          <a:prstGeom prst="rect">
            <a:avLst/>
          </a:prstGeom>
        </p:spPr>
      </p:pic>
      <p:pic>
        <p:nvPicPr>
          <p:cNvPr id="9" name="Picture 8" descr="Diagram, calendar&#10;&#10;Description automatically generated">
            <a:extLst>
              <a:ext uri="{FF2B5EF4-FFF2-40B4-BE49-F238E27FC236}">
                <a16:creationId xmlns:a16="http://schemas.microsoft.com/office/drawing/2014/main" id="{D68C6964-8A8D-4ED5-B973-972D8E4B770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69" b="49194"/>
          <a:stretch/>
        </p:blipFill>
        <p:spPr>
          <a:xfrm>
            <a:off x="115001" y="285890"/>
            <a:ext cx="5682795" cy="5617852"/>
          </a:xfrm>
          <a:prstGeom prst="rect">
            <a:avLst/>
          </a:prstGeom>
        </p:spPr>
      </p:pic>
      <p:pic>
        <p:nvPicPr>
          <p:cNvPr id="10" name="Picture 9" descr="Diagram, calendar&#10;&#10;Description automatically generated">
            <a:extLst>
              <a:ext uri="{FF2B5EF4-FFF2-40B4-BE49-F238E27FC236}">
                <a16:creationId xmlns:a16="http://schemas.microsoft.com/office/drawing/2014/main" id="{C9B742C1-185B-4E0B-9850-EB27F88D3B2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556" b="6049"/>
          <a:stretch/>
        </p:blipFill>
        <p:spPr>
          <a:xfrm>
            <a:off x="5725772" y="718568"/>
            <a:ext cx="5682795" cy="542086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A6886AB1-66B7-4B3C-B2EE-4A80D5296D04}"/>
              </a:ext>
            </a:extLst>
          </p:cNvPr>
          <p:cNvSpPr txBox="1"/>
          <p:nvPr/>
        </p:nvSpPr>
        <p:spPr>
          <a:xfrm>
            <a:off x="6024978" y="6211082"/>
            <a:ext cx="491782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: Forest plot including the overall pooled mortality estimate as well as subgroup analysis per etiology</a:t>
            </a:r>
          </a:p>
        </p:txBody>
      </p:sp>
    </p:spTree>
    <p:extLst>
      <p:ext uri="{BB962C8B-B14F-4D97-AF65-F5344CB8AC3E}">
        <p14:creationId xmlns:p14="http://schemas.microsoft.com/office/powerpoint/2010/main" val="3747067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xanne Assies</dc:creator>
  <cp:lastModifiedBy>Roxanne Assies</cp:lastModifiedBy>
  <cp:revision>1</cp:revision>
  <dcterms:created xsi:type="dcterms:W3CDTF">2022-05-05T12:20:11Z</dcterms:created>
  <dcterms:modified xsi:type="dcterms:W3CDTF">2022-05-05T12:38:37Z</dcterms:modified>
</cp:coreProperties>
</file>